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5" r:id="rId2"/>
    <p:sldId id="256" r:id="rId3"/>
    <p:sldId id="264" r:id="rId4"/>
    <p:sldId id="263" r:id="rId5"/>
    <p:sldId id="261" r:id="rId6"/>
    <p:sldId id="262" r:id="rId7"/>
  </p:sldIdLst>
  <p:sldSz cx="12192000" cy="6858000"/>
  <p:notesSz cx="6858000" cy="9144000"/>
  <p:defaultTextStyle>
    <a:defPPr>
      <a:defRPr lang="en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558"/>
    <p:restoredTop sz="94658"/>
  </p:normalViewPr>
  <p:slideViewPr>
    <p:cSldViewPr snapToGrid="0">
      <p:cViewPr varScale="1">
        <p:scale>
          <a:sx n="120" d="100"/>
          <a:sy n="120" d="100"/>
        </p:scale>
        <p:origin x="60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5CFFDB-9F05-050F-0034-2C5F2A9E94A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A946322-BA31-F19B-5775-4192DB4ECF4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1788B0-3F20-7805-573A-46E0C52FFF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C5DCAB-915F-2A41-BDEE-5D742955173D}" type="datetimeFigureOut">
              <a:rPr lang="en-SE" smtClean="0"/>
              <a:t>1/9/26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5D36E9-590B-BE31-C25D-A002BD75F9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A1C9AA-5286-6462-B326-FD98838B59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974AB-78DF-E249-A8D2-B0259D963A8A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8412745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2E45A4-F7D3-A4AD-1F34-3907D23235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8E2DA6F-56A2-0951-5443-8B1CAEF9FF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FF9049-A6A6-1476-AB14-81DF126C01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C5DCAB-915F-2A41-BDEE-5D742955173D}" type="datetimeFigureOut">
              <a:rPr lang="en-SE" smtClean="0"/>
              <a:t>1/9/26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E00D35-7056-3BFC-4E63-4E499CC40A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5A2B54-0F61-2E24-F671-9B9C46B01E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974AB-78DF-E249-A8D2-B0259D963A8A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2691215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3556831-7B30-B11E-07F1-FB1B8BDB1EA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A0E3261-2224-E4E2-5C3B-DD1221F290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5497D7-132F-0CC5-FE25-A707D3A81A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C5DCAB-915F-2A41-BDEE-5D742955173D}" type="datetimeFigureOut">
              <a:rPr lang="en-SE" smtClean="0"/>
              <a:t>1/9/26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AE81DA-9671-8B34-A378-B07391BA40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4298F2-F5B3-E5C3-7205-DD93255189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974AB-78DF-E249-A8D2-B0259D963A8A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3973448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4114F2-F7DD-5186-3CCE-927165D966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186291-10C9-26DB-1ED1-EC9A5B7CABF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078A6A-EB0A-5A0F-745C-E959B6FA20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C5DCAB-915F-2A41-BDEE-5D742955173D}" type="datetimeFigureOut">
              <a:rPr lang="en-SE" smtClean="0"/>
              <a:t>1/9/26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E9F0EB-073C-4DD7-E98C-440D8EF765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AAEF8C-0E46-FE96-11FD-061C1FCC21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974AB-78DF-E249-A8D2-B0259D963A8A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42007821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0A9A34-E13A-286F-556D-05F7A1C138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C26431C-49E7-5FAC-50A7-45EBB90BCE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12FDF5-4219-9244-9EE5-6A23623D7F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C5DCAB-915F-2A41-BDEE-5D742955173D}" type="datetimeFigureOut">
              <a:rPr lang="en-SE" smtClean="0"/>
              <a:t>1/9/26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A6ED8F-94B7-EE30-C244-7A676AA1A5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92691D-5ACB-DC0E-EB74-6DA0F1FEC9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974AB-78DF-E249-A8D2-B0259D963A8A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42890667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1BB16C-4C6F-FFAB-FB1F-A38D4F7957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669122-6BF6-35A1-087E-1F804E7ABB0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E4B2066-9C18-B3ED-E8C2-E81C4518BF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83C14E-FB77-AF40-C053-F1E3494659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C5DCAB-915F-2A41-BDEE-5D742955173D}" type="datetimeFigureOut">
              <a:rPr lang="en-SE" smtClean="0"/>
              <a:t>1/9/26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030CE5A-3B94-FB9C-448B-93436188B2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6D8DC87-CC46-C72B-7ACE-4CE8EF5581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974AB-78DF-E249-A8D2-B0259D963A8A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5090792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3E4E20-B33A-B8BB-2795-FD5990A3C7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E69FAF7-6C00-9CF1-9244-DE9308E5B7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DB633CF-7CAD-8939-CFC0-692AE9AAFC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E378713-208A-6BD5-0752-05E0B0725BB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34A9463-1CF1-EE8D-0BCA-F7D03918DE8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2F0A966-566D-5CB0-4982-041FBD5F7D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C5DCAB-915F-2A41-BDEE-5D742955173D}" type="datetimeFigureOut">
              <a:rPr lang="en-SE" smtClean="0"/>
              <a:t>1/9/26</a:t>
            </a:fld>
            <a:endParaRPr lang="en-S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4741304-2D5F-6C2D-E5E5-B70F055023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9EFC32C-3FB9-AF88-836D-E343CA7B98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974AB-78DF-E249-A8D2-B0259D963A8A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0460776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B20485-06BB-4598-209C-CDF956D6D1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9A413AD-C699-7446-D81A-0F1FA2335B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C5DCAB-915F-2A41-BDEE-5D742955173D}" type="datetimeFigureOut">
              <a:rPr lang="en-SE" smtClean="0"/>
              <a:t>1/9/26</a:t>
            </a:fld>
            <a:endParaRPr lang="en-S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369C850-A2E4-023B-DA79-3D071DD01B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D186C8E-54F0-3439-347F-0F655BF031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974AB-78DF-E249-A8D2-B0259D963A8A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0503691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418C79A-1D12-A5D3-263C-553590AB2A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C5DCAB-915F-2A41-BDEE-5D742955173D}" type="datetimeFigureOut">
              <a:rPr lang="en-SE" smtClean="0"/>
              <a:t>1/9/26</a:t>
            </a:fld>
            <a:endParaRPr lang="en-S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6F3D18C-196B-17D8-13D0-65090EB98A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31A2931-CB60-0292-6CC3-2041D1F990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974AB-78DF-E249-A8D2-B0259D963A8A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3971811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3B9635-7F85-7250-9B24-2495657B94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ECB2D4F-29B3-BEEE-6105-6C6B98151E6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BFB7B9C-AAC6-3E03-4BCC-A06F226139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21BA6E-D06D-1CB5-530E-B9A5D44461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C5DCAB-915F-2A41-BDEE-5D742955173D}" type="datetimeFigureOut">
              <a:rPr lang="en-SE" smtClean="0"/>
              <a:t>1/9/26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3BE26F-134F-C4D3-1802-72AF8E5A72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1433E2-0C32-F4D6-701E-8A418B7048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974AB-78DF-E249-A8D2-B0259D963A8A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2862135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AE9682-D144-4863-F87A-7053EE59E6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711F0DE-303D-6BAC-0E17-4CD3FD071B6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7AAF6D4-4E26-C2F3-5CC1-D618EFFD94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0E30C0-7699-C838-6CB0-78EF8284A5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C5DCAB-915F-2A41-BDEE-5D742955173D}" type="datetimeFigureOut">
              <a:rPr lang="en-SE" smtClean="0"/>
              <a:t>1/9/26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6CF030-5E74-3573-6FBE-46760E6CAE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552DE6-FB96-07BC-5DA5-A02E9ABEFB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974AB-78DF-E249-A8D2-B0259D963A8A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3641777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6404014-5C8D-5AE0-24B6-38078D2FC8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CB3743D-FF81-8850-6E44-C4D3FA8ED5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49DBA5-F733-72FC-F2E6-716A578C2CD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7C5DCAB-915F-2A41-BDEE-5D742955173D}" type="datetimeFigureOut">
              <a:rPr lang="en-SE" smtClean="0"/>
              <a:t>1/9/26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0B923D-0E91-5C4D-8973-B0897A3119D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1ECB5E-6A50-D108-1FD1-3BA78337E0C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9A974AB-78DF-E249-A8D2-B0259D963A8A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0946695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id="{9131ECE2-CD53-B211-DE31-2A4D0F065041}"/>
              </a:ext>
            </a:extLst>
          </p:cNvPr>
          <p:cNvGrpSpPr/>
          <p:nvPr/>
        </p:nvGrpSpPr>
        <p:grpSpPr>
          <a:xfrm>
            <a:off x="2927861" y="863709"/>
            <a:ext cx="6219972" cy="4489366"/>
            <a:chOff x="1503087" y="2319680"/>
            <a:chExt cx="5085617" cy="4012500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F91D9544-7051-FA17-CB8D-4A83C0D49A54}"/>
                </a:ext>
              </a:extLst>
            </p:cNvPr>
            <p:cNvSpPr txBox="1"/>
            <p:nvPr/>
          </p:nvSpPr>
          <p:spPr>
            <a:xfrm>
              <a:off x="3628031" y="2319680"/>
              <a:ext cx="591369" cy="3301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err="1"/>
                <a:t>siCtrl</a:t>
              </a:r>
              <a:endParaRPr lang="en-US" dirty="0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674375B-15FF-810A-6637-8E1CE81110D0}"/>
                </a:ext>
              </a:extLst>
            </p:cNvPr>
            <p:cNvSpPr txBox="1"/>
            <p:nvPr/>
          </p:nvSpPr>
          <p:spPr>
            <a:xfrm>
              <a:off x="5477809" y="2319680"/>
              <a:ext cx="1110895" cy="3301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siIP</a:t>
              </a:r>
              <a:r>
                <a:rPr lang="en-US" baseline="-25000" dirty="0"/>
                <a:t>3</a:t>
              </a:r>
              <a:r>
                <a:rPr lang="en-US" dirty="0"/>
                <a:t>R</a:t>
              </a:r>
            </a:p>
          </p:txBody>
        </p:sp>
        <p:pic>
          <p:nvPicPr>
            <p:cNvPr id="6" name="Picture 5" descr="A close-up of a test tube&#10;&#10;AI-generated content may be incorrect.">
              <a:extLst>
                <a:ext uri="{FF2B5EF4-FFF2-40B4-BE49-F238E27FC236}">
                  <a16:creationId xmlns:a16="http://schemas.microsoft.com/office/drawing/2014/main" id="{E42FCE48-0248-AFEC-8AF0-8435DB2A527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alphaModFix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  <a14:imgEffect>
                        <a14:saturation sat="376000"/>
                      </a14:imgEffect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rcRect t="18306"/>
            <a:stretch>
              <a:fillRect/>
            </a:stretch>
          </p:blipFill>
          <p:spPr>
            <a:xfrm>
              <a:off x="1503087" y="2602167"/>
              <a:ext cx="4824132" cy="3730013"/>
            </a:xfrm>
            <a:prstGeom prst="rect">
              <a:avLst/>
            </a:prstGeom>
            <a:gradFill>
              <a:gsLst>
                <a:gs pos="0">
                  <a:schemeClr val="accent1">
                    <a:lumMod val="22000"/>
                    <a:lumOff val="78000"/>
                  </a:schemeClr>
                </a:gs>
                <a:gs pos="74000">
                  <a:schemeClr val="accent1">
                    <a:lumMod val="45000"/>
                    <a:lumOff val="55000"/>
                  </a:schemeClr>
                </a:gs>
                <a:gs pos="83000">
                  <a:schemeClr val="accent1">
                    <a:lumMod val="45000"/>
                    <a:lumOff val="55000"/>
                  </a:schemeClr>
                </a:gs>
                <a:gs pos="100000">
                  <a:schemeClr val="accent1">
                    <a:lumMod val="30000"/>
                    <a:lumOff val="70000"/>
                  </a:schemeClr>
                </a:gs>
              </a:gsLst>
              <a:lin ang="5400000" scaled="1"/>
            </a:gradFill>
            <a:effectLst>
              <a:outerShdw blurRad="800100" dir="17220000" algn="ctr" rotWithShape="0">
                <a:schemeClr val="tx1">
                  <a:alpha val="0"/>
                </a:schemeClr>
              </a:outerShdw>
              <a:reflection endPos="0" dist="50800" dir="5400000" sy="-100000" algn="bl" rotWithShape="0"/>
            </a:effectLst>
          </p:spPr>
        </p:pic>
        <p:cxnSp>
          <p:nvCxnSpPr>
            <p:cNvPr id="8" name="Straight Arrow Connector 7">
              <a:extLst>
                <a:ext uri="{FF2B5EF4-FFF2-40B4-BE49-F238E27FC236}">
                  <a16:creationId xmlns:a16="http://schemas.microsoft.com/office/drawing/2014/main" id="{A7969D57-9ED3-75CB-A5D9-833264B6E5C7}"/>
                </a:ext>
              </a:extLst>
            </p:cNvPr>
            <p:cNvCxnSpPr>
              <a:cxnSpLocks/>
            </p:cNvCxnSpPr>
            <p:nvPr/>
          </p:nvCxnSpPr>
          <p:spPr>
            <a:xfrm>
              <a:off x="2715065" y="3886122"/>
              <a:ext cx="576775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1E82022-A885-F57B-C060-6B32C19E5F2F}"/>
                </a:ext>
              </a:extLst>
            </p:cNvPr>
            <p:cNvSpPr txBox="1"/>
            <p:nvPr/>
          </p:nvSpPr>
          <p:spPr>
            <a:xfrm>
              <a:off x="2686927" y="3492225"/>
              <a:ext cx="489138" cy="3301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IP</a:t>
              </a:r>
              <a:r>
                <a:rPr lang="en-US" baseline="-25000" dirty="0"/>
                <a:t>3</a:t>
              </a:r>
              <a:r>
                <a:rPr lang="en-US" dirty="0"/>
                <a:t>R</a:t>
              </a:r>
            </a:p>
          </p:txBody>
        </p: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AC1F6282-25E8-E2CD-130C-FC4492DF6D5E}"/>
              </a:ext>
            </a:extLst>
          </p:cNvPr>
          <p:cNvSpPr txBox="1"/>
          <p:nvPr/>
        </p:nvSpPr>
        <p:spPr>
          <a:xfrm>
            <a:off x="2347751" y="2197900"/>
            <a:ext cx="5549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710305F-EB9A-B49B-0D9F-682073DA7C52}"/>
              </a:ext>
            </a:extLst>
          </p:cNvPr>
          <p:cNvSpPr txBox="1"/>
          <p:nvPr/>
        </p:nvSpPr>
        <p:spPr>
          <a:xfrm>
            <a:off x="2366339" y="3376208"/>
            <a:ext cx="5549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C5029DD-D2E8-B20E-61D4-B500ABAA3530}"/>
              </a:ext>
            </a:extLst>
          </p:cNvPr>
          <p:cNvSpPr txBox="1"/>
          <p:nvPr/>
        </p:nvSpPr>
        <p:spPr>
          <a:xfrm>
            <a:off x="2429531" y="4175375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95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8795F65-D286-EE1B-D734-9B769ED48DFF}"/>
              </a:ext>
            </a:extLst>
          </p:cNvPr>
          <p:cNvSpPr txBox="1"/>
          <p:nvPr/>
        </p:nvSpPr>
        <p:spPr>
          <a:xfrm>
            <a:off x="2470421" y="4840726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2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B7BFFEF-28AC-B336-4453-C3206A977389}"/>
              </a:ext>
            </a:extLst>
          </p:cNvPr>
          <p:cNvSpPr txBox="1"/>
          <p:nvPr/>
        </p:nvSpPr>
        <p:spPr>
          <a:xfrm>
            <a:off x="2370058" y="916981"/>
            <a:ext cx="5787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kDa</a:t>
            </a:r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FC406EE-6B91-0260-515F-89DD52FE0F01}"/>
              </a:ext>
            </a:extLst>
          </p:cNvPr>
          <p:cNvSpPr txBox="1"/>
          <p:nvPr/>
        </p:nvSpPr>
        <p:spPr>
          <a:xfrm>
            <a:off x="602835" y="5835435"/>
            <a:ext cx="1146455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buNone/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: Silencing of IP</a:t>
            </a:r>
            <a:r>
              <a:rPr lang="en-US" sz="1200" b="1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 in HeLa cells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just">
              <a:buNone/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mmunoblot showing IP</a:t>
            </a:r>
            <a:r>
              <a:rPr lang="en-US" sz="12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 at 220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arrow) in the control cells,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iCtrl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and a faint band in the silenced cells, siIP</a:t>
            </a:r>
            <a:r>
              <a:rPr lang="en-US" sz="12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. </a:t>
            </a:r>
          </a:p>
        </p:txBody>
      </p:sp>
    </p:spTree>
    <p:extLst>
      <p:ext uri="{BB962C8B-B14F-4D97-AF65-F5344CB8AC3E}">
        <p14:creationId xmlns:p14="http://schemas.microsoft.com/office/powerpoint/2010/main" val="3609783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F6AB5648-4CE7-5383-3224-A6CD8FED993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621" y="764089"/>
            <a:ext cx="2839759" cy="4580802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A847658-D0B5-84C5-1FA0-9F35F5372A3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26432" y="928929"/>
            <a:ext cx="2839759" cy="418402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C8D0CF1-0BD4-1549-4122-7674A6560AF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72774" y="905354"/>
            <a:ext cx="2775829" cy="410486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2687B4A-5734-6DF7-7C03-88A280ED43E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728705" y="1005068"/>
            <a:ext cx="2765184" cy="375997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8EB91F1-1746-3E41-1E10-F14295015866}"/>
              </a:ext>
            </a:extLst>
          </p:cNvPr>
          <p:cNvSpPr txBox="1"/>
          <p:nvPr/>
        </p:nvSpPr>
        <p:spPr>
          <a:xfrm>
            <a:off x="123789" y="203200"/>
            <a:ext cx="3754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2400" b="1" dirty="0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E4E16FF-345E-030C-D597-8DB1BBD03A3E}"/>
              </a:ext>
            </a:extLst>
          </p:cNvPr>
          <p:cNvSpPr txBox="1"/>
          <p:nvPr/>
        </p:nvSpPr>
        <p:spPr>
          <a:xfrm>
            <a:off x="2899403" y="203200"/>
            <a:ext cx="3754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2400" b="1" dirty="0"/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3194486-DEFE-F4B2-650D-74C389F836F2}"/>
              </a:ext>
            </a:extLst>
          </p:cNvPr>
          <p:cNvSpPr txBox="1"/>
          <p:nvPr/>
        </p:nvSpPr>
        <p:spPr>
          <a:xfrm>
            <a:off x="5966666" y="203200"/>
            <a:ext cx="4026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2400" b="1" dirty="0"/>
              <a:t>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094F4F2-8D35-38CC-6C2E-EF1C2DB147D3}"/>
              </a:ext>
            </a:extLst>
          </p:cNvPr>
          <p:cNvSpPr txBox="1"/>
          <p:nvPr/>
        </p:nvSpPr>
        <p:spPr>
          <a:xfrm>
            <a:off x="8666075" y="203200"/>
            <a:ext cx="4026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2400" b="1" dirty="0"/>
              <a:t>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DDA4B09-7434-4F7C-67FF-7E092BC00542}"/>
              </a:ext>
            </a:extLst>
          </p:cNvPr>
          <p:cNvSpPr txBox="1"/>
          <p:nvPr/>
        </p:nvSpPr>
        <p:spPr>
          <a:xfrm>
            <a:off x="123789" y="5322138"/>
            <a:ext cx="1191372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Supplementary Fig 2: Source data related to Fig 1. </a:t>
            </a:r>
          </a:p>
          <a:p>
            <a:pPr algn="just"/>
            <a:r>
              <a:rPr lang="en-GB" sz="1200" dirty="0"/>
              <a:t>HeLa cells were incubated with inhibitors of cellular signalling pathways. </a:t>
            </a:r>
            <a:r>
              <a:rPr lang="en-GB" sz="1200" b="1" dirty="0"/>
              <a:t>(A)</a:t>
            </a:r>
            <a:r>
              <a:rPr lang="en-GB" sz="1200" dirty="0"/>
              <a:t> HeLa cells were incubated with Shiga toxin 1 (Stx1, n=6) or with Stx1 and pertussis toxin as a Gi/o-protein blocker (n=6). </a:t>
            </a:r>
            <a:r>
              <a:rPr lang="en-GB" sz="1200" b="1" dirty="0"/>
              <a:t>(</a:t>
            </a:r>
            <a:r>
              <a:rPr lang="en-US" sz="1200" b="1" dirty="0"/>
              <a:t>B)</a:t>
            </a:r>
            <a:r>
              <a:rPr lang="en-US" sz="1200" dirty="0"/>
              <a:t> HeLa cells were treated with Stx1 and DMSO (n=12) or with Stx1 and wortmannin (phosphoinositide 3-kinase inhibitor, n=12). </a:t>
            </a:r>
            <a:r>
              <a:rPr lang="en-US" sz="1200" b="1" dirty="0"/>
              <a:t>(C)</a:t>
            </a:r>
            <a:r>
              <a:rPr lang="en-US" sz="1200" dirty="0"/>
              <a:t> HeLa cells were treated with Stx1 and DMSO (n=8) or Stx1 and manoalide (phospholipase C inhibitor, n=8). </a:t>
            </a:r>
            <a:r>
              <a:rPr lang="en-US" sz="1200" b="1" dirty="0"/>
              <a:t>(D)</a:t>
            </a:r>
            <a:r>
              <a:rPr lang="en-US" sz="1200" dirty="0"/>
              <a:t> HeLa cells were treated with Stx1 and DMSO (n=9) or Stx1 and 2-APB (inositol 1,4,5-triphosphate receptor inhibitor, n=9). </a:t>
            </a:r>
            <a:r>
              <a:rPr lang="en-GB" sz="1200" dirty="0"/>
              <a:t>Each data point represents a mean of 4 technical replicates from one experiment. </a:t>
            </a:r>
            <a:r>
              <a:rPr lang="en-US" sz="1200"/>
              <a:t>Median luminescence </a:t>
            </a:r>
            <a:r>
              <a:rPr lang="en-US" sz="1200" dirty="0"/>
              <a:t>is denoted by the bar. *: P &lt;0.05, **: P &lt;0.01, ***: P &lt;0.001.  Wilcoxon signed-rank test in which data from the same experiment were paired. </a:t>
            </a:r>
          </a:p>
        </p:txBody>
      </p:sp>
    </p:spTree>
    <p:extLst>
      <p:ext uri="{BB962C8B-B14F-4D97-AF65-F5344CB8AC3E}">
        <p14:creationId xmlns:p14="http://schemas.microsoft.com/office/powerpoint/2010/main" val="35695519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EE999E0-7976-8A5F-2D05-721BE434744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62D34BF-1B9F-B334-E96F-A15476CDF6BB}"/>
              </a:ext>
            </a:extLst>
          </p:cNvPr>
          <p:cNvSpPr txBox="1"/>
          <p:nvPr/>
        </p:nvSpPr>
        <p:spPr>
          <a:xfrm>
            <a:off x="0" y="5681925"/>
            <a:ext cx="1219200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200" b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Supplementary Fig 3: Source data related to Fig 2. </a:t>
            </a:r>
            <a:endParaRPr lang="en-GB" sz="12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HeLa cells were treated with 2-APB or DMSO followed by (A) Shiga toxin 1 (Stx1) or (B) Stx2 for 24 h and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analyzed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for apoptosis as determined by caspase 3/7 activation. Stx1-stimulated cells (with DMSO vehicle) had significantly more caspase 3/7 activation compared to cells without Stx1 treated with and without 2-APB (n=10). (C) HeLa cells were treated with siRNA targeting IP</a:t>
            </a:r>
            <a:r>
              <a:rPr lang="en-GB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 (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iIP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)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or a control siRNA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for 72 h followed by incubation with Stx1 for 24 h and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analyzed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for caspase 3/7 activation. Each data point is acquired from all cells in 16 separate images from one well. Median fluorescence per cell is denoted by the bar. ***, P&lt; 0.001, **, P&lt; 0.01. Kruskal-Wallis test, followed by Dunn’s procedure. </a:t>
            </a:r>
            <a:endParaRPr lang="en-GB" sz="12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C71D7A2-7B86-0D40-9CA3-D388F2172483}"/>
              </a:ext>
            </a:extLst>
          </p:cNvPr>
          <p:cNvSpPr txBox="1"/>
          <p:nvPr/>
        </p:nvSpPr>
        <p:spPr>
          <a:xfrm>
            <a:off x="818368" y="7253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735F73E-4B27-8B10-D730-F97536231E1D}"/>
              </a:ext>
            </a:extLst>
          </p:cNvPr>
          <p:cNvSpPr txBox="1"/>
          <p:nvPr/>
        </p:nvSpPr>
        <p:spPr>
          <a:xfrm>
            <a:off x="4646906" y="7623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848C207-ADF4-719D-C087-65E1AF46E36D}"/>
              </a:ext>
            </a:extLst>
          </p:cNvPr>
          <p:cNvSpPr txBox="1"/>
          <p:nvPr/>
        </p:nvSpPr>
        <p:spPr>
          <a:xfrm>
            <a:off x="8351157" y="7253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248A90D-C70A-DF33-51DF-0750B4D2810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51157" y="609694"/>
            <a:ext cx="3378181" cy="398589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A57B1D1-9013-F5CE-B738-4F61C094577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1225" y="392164"/>
            <a:ext cx="3672348" cy="4207079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C76D0B41-AB08-0787-7EFB-733C37E5603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49606" y="160412"/>
            <a:ext cx="3752290" cy="44115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402834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B2CB034-E1A0-292E-65C0-E568B32C33A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ruta 3">
            <a:extLst>
              <a:ext uri="{FF2B5EF4-FFF2-40B4-BE49-F238E27FC236}">
                <a16:creationId xmlns:a16="http://schemas.microsoft.com/office/drawing/2014/main" id="{724DF3F8-CA02-4250-1779-C989D025599A}"/>
              </a:ext>
            </a:extLst>
          </p:cNvPr>
          <p:cNvSpPr txBox="1"/>
          <p:nvPr/>
        </p:nvSpPr>
        <p:spPr>
          <a:xfrm>
            <a:off x="842808" y="303001"/>
            <a:ext cx="3184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sv-S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sv-SE" sz="2400" dirty="0">
                <a:latin typeface="Helvetica" pitchFamily="2" charset="0"/>
              </a:rPr>
              <a:t>A</a:t>
            </a:r>
          </a:p>
        </p:txBody>
      </p:sp>
      <p:sp>
        <p:nvSpPr>
          <p:cNvPr id="7" name="textruta 4">
            <a:extLst>
              <a:ext uri="{FF2B5EF4-FFF2-40B4-BE49-F238E27FC236}">
                <a16:creationId xmlns:a16="http://schemas.microsoft.com/office/drawing/2014/main" id="{F79935F9-482D-C549-8080-E6161BAAA317}"/>
              </a:ext>
            </a:extLst>
          </p:cNvPr>
          <p:cNvSpPr txBox="1"/>
          <p:nvPr/>
        </p:nvSpPr>
        <p:spPr>
          <a:xfrm>
            <a:off x="5827464" y="289479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sv-S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sv-SE" sz="2400" dirty="0">
                <a:latin typeface="Helvetica" pitchFamily="2" charset="0"/>
              </a:rPr>
              <a:t>B</a:t>
            </a:r>
          </a:p>
        </p:txBody>
      </p:sp>
      <p:sp>
        <p:nvSpPr>
          <p:cNvPr id="8" name="textruta 11">
            <a:extLst>
              <a:ext uri="{FF2B5EF4-FFF2-40B4-BE49-F238E27FC236}">
                <a16:creationId xmlns:a16="http://schemas.microsoft.com/office/drawing/2014/main" id="{D0291B64-513B-528A-AD9D-C9C92FBA51C6}"/>
              </a:ext>
            </a:extLst>
          </p:cNvPr>
          <p:cNvSpPr txBox="1"/>
          <p:nvPr/>
        </p:nvSpPr>
        <p:spPr>
          <a:xfrm>
            <a:off x="1" y="5792144"/>
            <a:ext cx="12192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sv-S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 4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Manoalide and wortmannin do not protect HeLa cells from Shiga toxin 1-mediated caspase 3/7 activation</a:t>
            </a:r>
            <a:endParaRPr lang="sv-S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eLa cells were treated with manoalide (A) or wortmannin (B) at the indicated concentrations or with DMSO followed by Shiga toxin 1 (Stx1) for 24 h and analyzed for apoptosis as determined by caspase 3/7 activation. Each data point was acquired from all cells in 16 separate images from one sample. The median fluorescence per cell is denoted by the bar.</a:t>
            </a:r>
            <a:endParaRPr lang="en-S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CB7C678-F0A2-A7A7-8CCB-F94254359B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6895" y="904449"/>
            <a:ext cx="4586770" cy="467044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561679A-002A-4F10-C988-9F598C96351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56580" y="843713"/>
            <a:ext cx="4729523" cy="47936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1471189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518314" y="135811"/>
            <a:ext cx="46692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2800" dirty="0"/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726135" y="135811"/>
            <a:ext cx="46692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2800" dirty="0"/>
              <a:t>B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E66BF0B-C075-460C-0FB5-69F00D9CCF63}"/>
              </a:ext>
            </a:extLst>
          </p:cNvPr>
          <p:cNvSpPr txBox="1"/>
          <p:nvPr/>
        </p:nvSpPr>
        <p:spPr>
          <a:xfrm>
            <a:off x="0" y="5785921"/>
            <a:ext cx="12192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 5: Source data related to Fig 3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 (A) HeLa cells were incubated with BAPTA-AM, a cell permeant chelator, followed by stimulation with Shiga toxin 1 (Stx1) (n=19) and ATP levels detected by luminescence. Each data point is a technical repeat from 5 separate experiments. (B) HeLa cells were incubated in HBSS with and without exogenous Ca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then stimulated with Stx1. Significantly higher amounts of ATP were detected in the supernatant of Stx1-stimulated cells in the presence of Ca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ompared those in Ca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2+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ree media. Each data point is a technical repeat of 4 separate experiments. Median luminescence is denoted by the bar. **: P &lt;0.01, ****: P &lt;0.0001, Mann-Whitney test.</a:t>
            </a:r>
            <a:endParaRPr lang="en-SE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46D220F-4EAA-900F-2DD5-EE358987B3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59427" y="397421"/>
            <a:ext cx="3647842" cy="546145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A85196A-A6DA-6B46-2C71-4FF660C6BDE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72803" y="564247"/>
            <a:ext cx="3413319" cy="46545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442114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/>
        </p:nvGraphicFramePr>
        <p:xfrm>
          <a:off x="5820119" y="285327"/>
          <a:ext cx="3566247" cy="54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6326864" imgH="9577937" progId="Prism9.Document">
                  <p:embed/>
                </p:oleObj>
              </mc:Choice>
              <mc:Fallback>
                <p:oleObj name="Prism 9" r:id="rId2" imgW="6326864" imgH="9577937" progId="Prism9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820119" y="285327"/>
                        <a:ext cx="3566247" cy="54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3" name="Bildobjekt 2">
            <a:extLst>
              <a:ext uri="{FF2B5EF4-FFF2-40B4-BE49-F238E27FC236}">
                <a16:creationId xmlns:a16="http://schemas.microsoft.com/office/drawing/2014/main" id="{ED55759E-AA47-7F4A-BFDE-7AECEFD1F40C}"/>
              </a:ext>
            </a:extLst>
          </p:cNvPr>
          <p:cNvPicPr>
            <a:picLocks noChangeAspect="1"/>
          </p:cNvPicPr>
          <p:nvPr/>
        </p:nvPicPr>
        <p:blipFill>
          <a:blip r:embed="rId4">
            <a:biLevel thresh="75000"/>
          </a:blip>
          <a:stretch>
            <a:fillRect/>
          </a:stretch>
        </p:blipFill>
        <p:spPr>
          <a:xfrm>
            <a:off x="1959409" y="398441"/>
            <a:ext cx="2827139" cy="4752000"/>
          </a:xfrm>
          <a:prstGeom prst="rect">
            <a:avLst/>
          </a:prstGeom>
        </p:spPr>
      </p:pic>
      <p:sp>
        <p:nvSpPr>
          <p:cNvPr id="7" name="textruta 6">
            <a:extLst>
              <a:ext uri="{FF2B5EF4-FFF2-40B4-BE49-F238E27FC236}">
                <a16:creationId xmlns:a16="http://schemas.microsoft.com/office/drawing/2014/main" id="{4E8245D0-F59F-FD4B-946D-CB1B39A36516}"/>
              </a:ext>
            </a:extLst>
          </p:cNvPr>
          <p:cNvSpPr txBox="1"/>
          <p:nvPr/>
        </p:nvSpPr>
        <p:spPr>
          <a:xfrm>
            <a:off x="1360445" y="241737"/>
            <a:ext cx="45878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3200" dirty="0">
                <a:latin typeface="Helvetica" pitchFamily="2" charset="0"/>
              </a:rPr>
              <a:t>A</a:t>
            </a:r>
            <a:endParaRPr lang="sv-SE" dirty="0">
              <a:latin typeface="Helvetica" pitchFamily="2" charset="0"/>
            </a:endParaRPr>
          </a:p>
        </p:txBody>
      </p:sp>
      <p:sp>
        <p:nvSpPr>
          <p:cNvPr id="8" name="textruta 7">
            <a:extLst>
              <a:ext uri="{FF2B5EF4-FFF2-40B4-BE49-F238E27FC236}">
                <a16:creationId xmlns:a16="http://schemas.microsoft.com/office/drawing/2014/main" id="{2A88BD7A-B088-EB4A-B45F-AC06F93144AB}"/>
              </a:ext>
            </a:extLst>
          </p:cNvPr>
          <p:cNvSpPr txBox="1"/>
          <p:nvPr/>
        </p:nvSpPr>
        <p:spPr>
          <a:xfrm>
            <a:off x="5853171" y="241737"/>
            <a:ext cx="31771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3200" dirty="0">
                <a:latin typeface="Helvetica" pitchFamily="2" charset="0"/>
              </a:rPr>
              <a:t>B</a:t>
            </a:r>
            <a:endParaRPr lang="sv-SE" dirty="0">
              <a:latin typeface="Helvetica" pitchFamily="2" charset="0"/>
            </a:endParaRPr>
          </a:p>
        </p:txBody>
      </p:sp>
      <p:sp>
        <p:nvSpPr>
          <p:cNvPr id="12" name="textruta 11">
            <a:extLst>
              <a:ext uri="{FF2B5EF4-FFF2-40B4-BE49-F238E27FC236}">
                <a16:creationId xmlns:a16="http://schemas.microsoft.com/office/drawing/2014/main" id="{0D2A8C3F-0610-124C-AC19-1B0A8F9B83AB}"/>
              </a:ext>
            </a:extLst>
          </p:cNvPr>
          <p:cNvSpPr txBox="1"/>
          <p:nvPr/>
        </p:nvSpPr>
        <p:spPr>
          <a:xfrm>
            <a:off x="30822" y="5676444"/>
            <a:ext cx="1219199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 6: Intra- and extracellular Ca</a:t>
            </a:r>
            <a:r>
              <a:rPr lang="en-US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is involved in ATP release</a:t>
            </a:r>
            <a:endParaRPr lang="sv-S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) HeLa cells were incubated with or without BAPTA-AM followed by stimulation with distilled H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, to lower the osmolality. A significantly higher amount of ATP was found in the supernatant of H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 stimulated untreated cells compared to cells treated with BAPTA-AM (n=7). (B) HeLa cells were incubated in HBSS with and without exogenous Ca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then stimulated with H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. Significantly lower amounts of ATP were detected in the supernatant of H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-stimulated cells that were incubated in Ca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free HBSS compared to cells in Ca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HBSS (n=5). Each data point represents an independent experiment and is a mean of 4 technical repeats. Median ATP release is denoted by the bar. *: P&lt;0.05, **: P&lt;0.01, Mann-Whitney test.</a:t>
            </a:r>
            <a:endParaRPr lang="sv-S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58901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72</TotalTime>
  <Words>801</Words>
  <Application>Microsoft Macintosh PowerPoint</Application>
  <PresentationFormat>Widescreen</PresentationFormat>
  <Paragraphs>32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ptos</vt:lpstr>
      <vt:lpstr>Aptos Display</vt:lpstr>
      <vt:lpstr>Arial</vt:lpstr>
      <vt:lpstr>Helvetica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arl Johansson</dc:creator>
  <cp:lastModifiedBy>Diana Karpman</cp:lastModifiedBy>
  <cp:revision>28</cp:revision>
  <dcterms:created xsi:type="dcterms:W3CDTF">2025-09-01T06:50:22Z</dcterms:created>
  <dcterms:modified xsi:type="dcterms:W3CDTF">2026-01-09T13:07:53Z</dcterms:modified>
</cp:coreProperties>
</file>